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3" d="100"/>
          <a:sy n="43" d="100"/>
        </p:scale>
        <p:origin x="232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6"/>
            <a:ext cx="15300564" cy="6266897"/>
          </a:xfrm>
        </p:spPr>
        <p:txBody>
          <a:bodyPr anchor="b"/>
          <a:lstStyle>
            <a:lvl1pPr algn="ctr">
              <a:defRPr sz="11813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6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160" indent="0" algn="ctr">
              <a:buNone/>
              <a:defRPr sz="3938"/>
            </a:lvl2pPr>
            <a:lvl3pPr marL="1800322" indent="0" algn="ctr">
              <a:buNone/>
              <a:defRPr sz="3545"/>
            </a:lvl3pPr>
            <a:lvl4pPr marL="2700483" indent="0" algn="ctr">
              <a:buNone/>
              <a:defRPr sz="3150"/>
            </a:lvl4pPr>
            <a:lvl5pPr marL="3600645" indent="0" algn="ctr">
              <a:buNone/>
              <a:defRPr sz="3150"/>
            </a:lvl5pPr>
            <a:lvl6pPr marL="4500805" indent="0" algn="ctr">
              <a:buNone/>
              <a:defRPr sz="3150"/>
            </a:lvl6pPr>
            <a:lvl7pPr marL="5400965" indent="0" algn="ctr">
              <a:buNone/>
              <a:defRPr sz="3150"/>
            </a:lvl7pPr>
            <a:lvl8pPr marL="6301126" indent="0" algn="ctr">
              <a:buNone/>
              <a:defRPr sz="3150"/>
            </a:lvl8pPr>
            <a:lvl9pPr marL="7201288" indent="0" algn="ctr">
              <a:buNone/>
              <a:defRPr sz="315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9680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1894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8" y="958370"/>
            <a:ext cx="3881393" cy="1525473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9" y="958370"/>
            <a:ext cx="11419171" cy="1525473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0154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9417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4"/>
            <a:ext cx="15525572" cy="7487773"/>
          </a:xfrm>
        </p:spPr>
        <p:txBody>
          <a:bodyPr anchor="b"/>
          <a:lstStyle>
            <a:lvl1pPr>
              <a:defRPr sz="11813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3"/>
            <a:ext cx="15525572" cy="3937645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160" indent="0">
              <a:buNone/>
              <a:defRPr sz="3938">
                <a:solidFill>
                  <a:schemeClr val="tx1">
                    <a:tint val="75000"/>
                  </a:schemeClr>
                </a:solidFill>
              </a:defRPr>
            </a:lvl2pPr>
            <a:lvl3pPr marL="1800322" indent="0">
              <a:buNone/>
              <a:defRPr sz="3545">
                <a:solidFill>
                  <a:schemeClr val="tx1">
                    <a:tint val="75000"/>
                  </a:schemeClr>
                </a:solidFill>
              </a:defRPr>
            </a:lvl3pPr>
            <a:lvl4pPr marL="2700483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64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80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96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112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1288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54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5"/>
            <a:ext cx="7650282" cy="1142125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7" y="4791845"/>
            <a:ext cx="7650282" cy="1142125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3228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4"/>
            <a:ext cx="15525572" cy="347929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5" y="4412666"/>
            <a:ext cx="7615123" cy="2162579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160" indent="0">
              <a:buNone/>
              <a:defRPr sz="3938" b="1"/>
            </a:lvl2pPr>
            <a:lvl3pPr marL="1800322" indent="0">
              <a:buNone/>
              <a:defRPr sz="3545" b="1"/>
            </a:lvl3pPr>
            <a:lvl4pPr marL="2700483" indent="0">
              <a:buNone/>
              <a:defRPr sz="3150" b="1"/>
            </a:lvl4pPr>
            <a:lvl5pPr marL="3600645" indent="0">
              <a:buNone/>
              <a:defRPr sz="3150" b="1"/>
            </a:lvl5pPr>
            <a:lvl6pPr marL="4500805" indent="0">
              <a:buNone/>
              <a:defRPr sz="3150" b="1"/>
            </a:lvl6pPr>
            <a:lvl7pPr marL="5400965" indent="0">
              <a:buNone/>
              <a:defRPr sz="3150" b="1"/>
            </a:lvl7pPr>
            <a:lvl8pPr marL="6301126" indent="0">
              <a:buNone/>
              <a:defRPr sz="3150" b="1"/>
            </a:lvl8pPr>
            <a:lvl9pPr marL="7201288" indent="0">
              <a:buNone/>
              <a:defRPr sz="315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5" y="6575241"/>
            <a:ext cx="7615123" cy="967119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6"/>
            <a:ext cx="7652626" cy="2162579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160" indent="0">
              <a:buNone/>
              <a:defRPr sz="3938" b="1"/>
            </a:lvl2pPr>
            <a:lvl3pPr marL="1800322" indent="0">
              <a:buNone/>
              <a:defRPr sz="3545" b="1"/>
            </a:lvl3pPr>
            <a:lvl4pPr marL="2700483" indent="0">
              <a:buNone/>
              <a:defRPr sz="3150" b="1"/>
            </a:lvl4pPr>
            <a:lvl5pPr marL="3600645" indent="0">
              <a:buNone/>
              <a:defRPr sz="3150" b="1"/>
            </a:lvl5pPr>
            <a:lvl6pPr marL="4500805" indent="0">
              <a:buNone/>
              <a:defRPr sz="3150" b="1"/>
            </a:lvl6pPr>
            <a:lvl7pPr marL="5400965" indent="0">
              <a:buNone/>
              <a:defRPr sz="3150" b="1"/>
            </a:lvl7pPr>
            <a:lvl8pPr marL="6301126" indent="0">
              <a:buNone/>
              <a:defRPr sz="3150" b="1"/>
            </a:lvl8pPr>
            <a:lvl9pPr marL="7201288" indent="0">
              <a:buNone/>
              <a:defRPr sz="315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1"/>
            <a:ext cx="7652626" cy="967119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3023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9360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5873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7"/>
            <a:ext cx="5805682" cy="4200155"/>
          </a:xfrm>
        </p:spPr>
        <p:txBody>
          <a:bodyPr anchor="b"/>
          <a:lstStyle>
            <a:lvl1pPr>
              <a:defRPr sz="630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7"/>
            <a:ext cx="9112836" cy="12792139"/>
          </a:xfrm>
        </p:spPr>
        <p:txBody>
          <a:bodyPr/>
          <a:lstStyle>
            <a:lvl1pPr>
              <a:defRPr sz="6302"/>
            </a:lvl1pPr>
            <a:lvl2pPr>
              <a:defRPr sz="5513"/>
            </a:lvl2pPr>
            <a:lvl3pPr>
              <a:defRPr sz="4725"/>
            </a:lvl3pPr>
            <a:lvl4pPr>
              <a:defRPr sz="3938"/>
            </a:lvl4pPr>
            <a:lvl5pPr>
              <a:defRPr sz="3938"/>
            </a:lvl5pPr>
            <a:lvl6pPr>
              <a:defRPr sz="3938"/>
            </a:lvl6pPr>
            <a:lvl7pPr>
              <a:defRPr sz="3938"/>
            </a:lvl7pPr>
            <a:lvl8pPr>
              <a:defRPr sz="3938"/>
            </a:lvl8pPr>
            <a:lvl9pPr>
              <a:defRPr sz="393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200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160" indent="0">
              <a:buNone/>
              <a:defRPr sz="2757"/>
            </a:lvl2pPr>
            <a:lvl3pPr marL="1800322" indent="0">
              <a:buNone/>
              <a:defRPr sz="2362"/>
            </a:lvl3pPr>
            <a:lvl4pPr marL="2700483" indent="0">
              <a:buNone/>
              <a:defRPr sz="1968"/>
            </a:lvl4pPr>
            <a:lvl5pPr marL="3600645" indent="0">
              <a:buNone/>
              <a:defRPr sz="1968"/>
            </a:lvl5pPr>
            <a:lvl6pPr marL="4500805" indent="0">
              <a:buNone/>
              <a:defRPr sz="1968"/>
            </a:lvl6pPr>
            <a:lvl7pPr marL="5400965" indent="0">
              <a:buNone/>
              <a:defRPr sz="1968"/>
            </a:lvl7pPr>
            <a:lvl8pPr marL="6301126" indent="0">
              <a:buNone/>
              <a:defRPr sz="1968"/>
            </a:lvl8pPr>
            <a:lvl9pPr marL="7201288" indent="0">
              <a:buNone/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7989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7"/>
            <a:ext cx="5805682" cy="4200155"/>
          </a:xfrm>
        </p:spPr>
        <p:txBody>
          <a:bodyPr anchor="b"/>
          <a:lstStyle>
            <a:lvl1pPr>
              <a:defRPr sz="630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7"/>
            <a:ext cx="9112836" cy="12792139"/>
          </a:xfrm>
        </p:spPr>
        <p:txBody>
          <a:bodyPr anchor="t"/>
          <a:lstStyle>
            <a:lvl1pPr marL="0" indent="0">
              <a:buNone/>
              <a:defRPr sz="6302"/>
            </a:lvl1pPr>
            <a:lvl2pPr marL="900160" indent="0">
              <a:buNone/>
              <a:defRPr sz="5513"/>
            </a:lvl2pPr>
            <a:lvl3pPr marL="1800322" indent="0">
              <a:buNone/>
              <a:defRPr sz="4725"/>
            </a:lvl3pPr>
            <a:lvl4pPr marL="2700483" indent="0">
              <a:buNone/>
              <a:defRPr sz="3938"/>
            </a:lvl4pPr>
            <a:lvl5pPr marL="3600645" indent="0">
              <a:buNone/>
              <a:defRPr sz="3938"/>
            </a:lvl5pPr>
            <a:lvl6pPr marL="4500805" indent="0">
              <a:buNone/>
              <a:defRPr sz="3938"/>
            </a:lvl6pPr>
            <a:lvl7pPr marL="5400965" indent="0">
              <a:buNone/>
              <a:defRPr sz="3938"/>
            </a:lvl7pPr>
            <a:lvl8pPr marL="6301126" indent="0">
              <a:buNone/>
              <a:defRPr sz="3938"/>
            </a:lvl8pPr>
            <a:lvl9pPr marL="7201288" indent="0">
              <a:buNone/>
              <a:defRPr sz="393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200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160" indent="0">
              <a:buNone/>
              <a:defRPr sz="2757"/>
            </a:lvl2pPr>
            <a:lvl3pPr marL="1800322" indent="0">
              <a:buNone/>
              <a:defRPr sz="2362"/>
            </a:lvl3pPr>
            <a:lvl4pPr marL="2700483" indent="0">
              <a:buNone/>
              <a:defRPr sz="1968"/>
            </a:lvl4pPr>
            <a:lvl5pPr marL="3600645" indent="0">
              <a:buNone/>
              <a:defRPr sz="1968"/>
            </a:lvl5pPr>
            <a:lvl6pPr marL="4500805" indent="0">
              <a:buNone/>
              <a:defRPr sz="1968"/>
            </a:lvl6pPr>
            <a:lvl7pPr marL="5400965" indent="0">
              <a:buNone/>
              <a:defRPr sz="1968"/>
            </a:lvl7pPr>
            <a:lvl8pPr marL="6301126" indent="0">
              <a:buNone/>
              <a:defRPr sz="1968"/>
            </a:lvl8pPr>
            <a:lvl9pPr marL="7201288" indent="0">
              <a:buNone/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186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7" y="958374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7" y="4791845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9" y="16683952"/>
            <a:ext cx="4050149" cy="9583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DD2EAD-3277-46FA-A0FD-87212D02D853}" type="datetimeFigureOut">
              <a:rPr lang="ko-KR" altLang="en-US" smtClean="0"/>
              <a:t>2023-1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1" y="16683952"/>
            <a:ext cx="6075224" cy="9583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71" y="16683952"/>
            <a:ext cx="4050149" cy="9583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441D0-6ABC-4ED0-B6D5-E6CE016710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92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800322" rtl="0" eaLnBrk="1" latinLnBrk="1" hangingPunct="1">
        <a:lnSpc>
          <a:spcPct val="90000"/>
        </a:lnSpc>
        <a:spcBef>
          <a:spcPct val="0"/>
        </a:spcBef>
        <a:buNone/>
        <a:defRPr sz="86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80" indent="-450080" algn="l" defTabSz="1800322" rtl="0" eaLnBrk="1" latinLnBrk="1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5513" kern="1200">
          <a:solidFill>
            <a:schemeClr val="tx1"/>
          </a:solidFill>
          <a:latin typeface="+mn-lt"/>
          <a:ea typeface="+mn-ea"/>
          <a:cs typeface="+mn-cs"/>
        </a:defRPr>
      </a:lvl1pPr>
      <a:lvl2pPr marL="1350242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403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3938" kern="1200">
          <a:solidFill>
            <a:schemeClr val="tx1"/>
          </a:solidFill>
          <a:latin typeface="+mn-lt"/>
          <a:ea typeface="+mn-ea"/>
          <a:cs typeface="+mn-cs"/>
        </a:defRPr>
      </a:lvl3pPr>
      <a:lvl4pPr marL="3150563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4050725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950886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851046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751205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651367" indent="-450080" algn="l" defTabSz="1800322" rtl="0" eaLnBrk="1" latinLnBrk="1" hangingPunct="1">
        <a:lnSpc>
          <a:spcPct val="90000"/>
        </a:lnSpc>
        <a:spcBef>
          <a:spcPts val="983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1pPr>
      <a:lvl2pPr marL="900160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2pPr>
      <a:lvl3pPr marL="1800322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700483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3600645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500805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400965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301126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201288" algn="l" defTabSz="1800322" rtl="0" eaLnBrk="1" latinLnBrk="1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A0753533-05AD-E8C0-43C4-75BF0591EC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1074" y="413738"/>
            <a:ext cx="5646060" cy="56371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50E0D0E-8C21-7990-441A-14FBAAEBCC8F}"/>
              </a:ext>
            </a:extLst>
          </p:cNvPr>
          <p:cNvSpPr txBox="1"/>
          <p:nvPr/>
        </p:nvSpPr>
        <p:spPr>
          <a:xfrm>
            <a:off x="2234101" y="5624930"/>
            <a:ext cx="4672928" cy="52334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2801" dirty="0"/>
              <a:t>n=316      n=843      n=525</a:t>
            </a:r>
            <a:endParaRPr lang="ko-KR" altLang="en-US" sz="280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EFC5AA9-53CE-F690-3E03-38A611EBC199}"/>
              </a:ext>
            </a:extLst>
          </p:cNvPr>
          <p:cNvSpPr txBox="1"/>
          <p:nvPr/>
        </p:nvSpPr>
        <p:spPr>
          <a:xfrm rot="10800000">
            <a:off x="1082780" y="921888"/>
            <a:ext cx="615681" cy="3186546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lang="en-US" altLang="ko-KR" sz="2801" dirty="0"/>
              <a:t>FVC(L)</a:t>
            </a:r>
            <a:endParaRPr lang="ko-KR" altLang="en-US" sz="280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66216D-243E-05B7-C9E1-5A36B5D8EC23}"/>
              </a:ext>
            </a:extLst>
          </p:cNvPr>
          <p:cNvSpPr txBox="1"/>
          <p:nvPr/>
        </p:nvSpPr>
        <p:spPr>
          <a:xfrm>
            <a:off x="168442" y="621633"/>
            <a:ext cx="8848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600" b="1" dirty="0"/>
              <a:t>A</a:t>
            </a:r>
            <a:endParaRPr lang="ko-KR" altLang="en-US" sz="3600" b="1" dirty="0"/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E0E7D18C-F165-E75F-37D1-04245136A3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80161" y="413738"/>
            <a:ext cx="5743471" cy="573441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850C423-1332-C820-26F6-863E01E11934}"/>
              </a:ext>
            </a:extLst>
          </p:cNvPr>
          <p:cNvSpPr txBox="1"/>
          <p:nvPr/>
        </p:nvSpPr>
        <p:spPr>
          <a:xfrm>
            <a:off x="8814869" y="5512033"/>
            <a:ext cx="4672928" cy="52334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2801" dirty="0"/>
              <a:t>n=316       n=844      n=526</a:t>
            </a:r>
            <a:endParaRPr lang="ko-KR" altLang="en-US" sz="280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DA7190-2189-8C36-7FB6-86263E04CEC5}"/>
              </a:ext>
            </a:extLst>
          </p:cNvPr>
          <p:cNvSpPr txBox="1"/>
          <p:nvPr/>
        </p:nvSpPr>
        <p:spPr>
          <a:xfrm rot="10800000">
            <a:off x="7542774" y="944798"/>
            <a:ext cx="615681" cy="3186546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lang="en-US" altLang="ko-KR" sz="2801" dirty="0"/>
              <a:t>FEV1(L)</a:t>
            </a:r>
            <a:endParaRPr lang="ko-KR" altLang="en-US" sz="280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7A710D7-AE92-8211-0095-63A2CEA2AB81}"/>
              </a:ext>
            </a:extLst>
          </p:cNvPr>
          <p:cNvSpPr txBox="1"/>
          <p:nvPr/>
        </p:nvSpPr>
        <p:spPr>
          <a:xfrm>
            <a:off x="304802" y="6665845"/>
            <a:ext cx="8848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600" b="1" dirty="0"/>
              <a:t>B</a:t>
            </a:r>
            <a:endParaRPr lang="ko-KR" altLang="en-US" sz="3600" b="1" dirty="0"/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BB4B84F7-B4E0-39F6-B900-0707EE270D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1338" y="6345816"/>
            <a:ext cx="5646061" cy="5637156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7C7D178-BDD4-190F-22C4-DE27860C5CE8}"/>
              </a:ext>
            </a:extLst>
          </p:cNvPr>
          <p:cNvSpPr txBox="1"/>
          <p:nvPr/>
        </p:nvSpPr>
        <p:spPr>
          <a:xfrm rot="10800000">
            <a:off x="993496" y="6665844"/>
            <a:ext cx="615681" cy="3186546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lang="en-US" altLang="ko-KR" sz="2801" dirty="0"/>
              <a:t>FVC, 8Y (L)</a:t>
            </a:r>
            <a:endParaRPr lang="ko-KR" altLang="en-US" sz="280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46B34C-4628-E4A8-9A78-C3FBB2259045}"/>
              </a:ext>
            </a:extLst>
          </p:cNvPr>
          <p:cNvSpPr txBox="1"/>
          <p:nvPr/>
        </p:nvSpPr>
        <p:spPr>
          <a:xfrm>
            <a:off x="2284314" y="11566723"/>
            <a:ext cx="4672928" cy="52334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2801" dirty="0"/>
              <a:t>n=289       n=794     n=523</a:t>
            </a:r>
            <a:endParaRPr lang="ko-KR" altLang="en-US" sz="2801" dirty="0"/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BA817B60-4186-8E1F-C69D-DB62CD7429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80161" y="6345816"/>
            <a:ext cx="5646062" cy="5637156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9422BDF3-7A81-59C4-E795-42C88F61E048}"/>
              </a:ext>
            </a:extLst>
          </p:cNvPr>
          <p:cNvSpPr txBox="1"/>
          <p:nvPr/>
        </p:nvSpPr>
        <p:spPr>
          <a:xfrm>
            <a:off x="8853295" y="11657418"/>
            <a:ext cx="4672928" cy="52334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2801" dirty="0"/>
              <a:t>n=301       n=842      n=560</a:t>
            </a:r>
            <a:endParaRPr lang="ko-KR" altLang="en-US" sz="280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ED9D8F0-9D94-A59D-3EB6-FC28BC57C97C}"/>
              </a:ext>
            </a:extLst>
          </p:cNvPr>
          <p:cNvSpPr txBox="1"/>
          <p:nvPr/>
        </p:nvSpPr>
        <p:spPr>
          <a:xfrm rot="10800000">
            <a:off x="7591884" y="6964798"/>
            <a:ext cx="615681" cy="4071067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lang="en-US" altLang="ko-KR" sz="2801" dirty="0"/>
              <a:t>Total Lean Mass, 9Y  (kg)</a:t>
            </a:r>
            <a:endParaRPr lang="ko-KR" altLang="en-US" sz="2801" dirty="0"/>
          </a:p>
        </p:txBody>
      </p:sp>
      <p:pic>
        <p:nvPicPr>
          <p:cNvPr id="24" name="그림 23">
            <a:extLst>
              <a:ext uri="{FF2B5EF4-FFF2-40B4-BE49-F238E27FC236}">
                <a16:creationId xmlns:a16="http://schemas.microsoft.com/office/drawing/2014/main" id="{A662477E-AAE1-483B-DB7A-6CA1A163DE4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01337" y="12062736"/>
            <a:ext cx="5605693" cy="5596851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CABCF6A3-CEBE-55FB-90F9-3B345359C425}"/>
              </a:ext>
            </a:extLst>
          </p:cNvPr>
          <p:cNvSpPr txBox="1"/>
          <p:nvPr/>
        </p:nvSpPr>
        <p:spPr>
          <a:xfrm rot="10800000">
            <a:off x="881815" y="12465285"/>
            <a:ext cx="615681" cy="3186546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lang="en-US" altLang="ko-KR" sz="2801" dirty="0"/>
              <a:t>BMI, 7Y (kg/m</a:t>
            </a:r>
            <a:r>
              <a:rPr lang="en-US" altLang="ko-KR" sz="2801" baseline="30000" dirty="0"/>
              <a:t>2</a:t>
            </a:r>
            <a:r>
              <a:rPr lang="en-US" altLang="ko-KR" sz="2801" dirty="0"/>
              <a:t>)</a:t>
            </a:r>
            <a:endParaRPr lang="ko-KR" altLang="en-US" sz="280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6516C80-5810-C4BB-3297-A2DC06231F0E}"/>
              </a:ext>
            </a:extLst>
          </p:cNvPr>
          <p:cNvSpPr txBox="1"/>
          <p:nvPr/>
        </p:nvSpPr>
        <p:spPr>
          <a:xfrm>
            <a:off x="2234101" y="17208555"/>
            <a:ext cx="4672928" cy="52334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2801" dirty="0"/>
              <a:t>n=320      n=865      n=577</a:t>
            </a:r>
            <a:endParaRPr lang="ko-KR" altLang="en-US" sz="2801" dirty="0"/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FBEEE18B-F80E-915F-D260-68BEA6D9CF8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903588" y="12097577"/>
            <a:ext cx="5622636" cy="5613768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0A81EBC1-F2F2-9C9A-F2FD-CD5131E3F85A}"/>
              </a:ext>
            </a:extLst>
          </p:cNvPr>
          <p:cNvSpPr txBox="1"/>
          <p:nvPr/>
        </p:nvSpPr>
        <p:spPr>
          <a:xfrm rot="10800000">
            <a:off x="7542776" y="12689874"/>
            <a:ext cx="615681" cy="3186546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r>
              <a:rPr lang="en-US" altLang="ko-KR" sz="2801" dirty="0"/>
              <a:t>BMI, 15Y (kg/m</a:t>
            </a:r>
            <a:r>
              <a:rPr lang="en-US" altLang="ko-KR" sz="2801" baseline="30000" dirty="0"/>
              <a:t>2</a:t>
            </a:r>
            <a:r>
              <a:rPr lang="en-US" altLang="ko-KR" sz="2801" dirty="0"/>
              <a:t>)</a:t>
            </a:r>
            <a:endParaRPr lang="ko-KR" altLang="en-US" sz="280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EA30822-A742-F627-4343-8F45FE4CB172}"/>
              </a:ext>
            </a:extLst>
          </p:cNvPr>
          <p:cNvSpPr txBox="1"/>
          <p:nvPr/>
        </p:nvSpPr>
        <p:spPr>
          <a:xfrm>
            <a:off x="8854452" y="17229063"/>
            <a:ext cx="4672928" cy="52334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2801" dirty="0"/>
              <a:t>n=298       n=798      n=512</a:t>
            </a:r>
            <a:endParaRPr lang="ko-KR" altLang="en-US" sz="2801" dirty="0"/>
          </a:p>
        </p:txBody>
      </p:sp>
      <p:sp>
        <p:nvSpPr>
          <p:cNvPr id="2" name="직사각형 1"/>
          <p:cNvSpPr/>
          <p:nvPr/>
        </p:nvSpPr>
        <p:spPr>
          <a:xfrm>
            <a:off x="287337" y="156756"/>
            <a:ext cx="5459828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600" b="1" dirty="0">
                <a:latin typeface="Times New Roman" panose="02020603050405020304" pitchFamily="18" charset="0"/>
              </a:rPr>
              <a:t>Supplementary Figure S8. </a:t>
            </a:r>
            <a:endParaRPr lang="ko-KR" altLang="en-US" sz="3600" dirty="0"/>
          </a:p>
        </p:txBody>
      </p:sp>
    </p:spTree>
    <p:extLst>
      <p:ext uri="{BB962C8B-B14F-4D97-AF65-F5344CB8AC3E}">
        <p14:creationId xmlns:p14="http://schemas.microsoft.com/office/powerpoint/2010/main" val="436891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29</TotalTime>
  <Words>54</Words>
  <Application>Microsoft Office PowerPoint</Application>
  <PresentationFormat>사용자 지정</PresentationFormat>
  <Paragraphs>1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온정헌</dc:creator>
  <cp:lastModifiedBy>온정헌</cp:lastModifiedBy>
  <cp:revision>88</cp:revision>
  <dcterms:created xsi:type="dcterms:W3CDTF">2022-12-09T06:57:52Z</dcterms:created>
  <dcterms:modified xsi:type="dcterms:W3CDTF">2023-12-15T09:30:50Z</dcterms:modified>
</cp:coreProperties>
</file>